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4" d="100"/>
          <a:sy n="84" d="100"/>
        </p:scale>
        <p:origin x="557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novo\Desktop\JAZ%20repeat%20HRs\Analysis%20for%20pANDA%20and%20OEJAZ%20Aug%201%20202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novo\Desktop\JAZ%20repeat%20HRs\Analysis%20for%20pANDA%20and%20OEJAZ%20Aug%201%202023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enovo\Desktop\JAZ%20repeat%20HRs\qJAZ1-9%20primers%20Bio-Rad%202-step%20qRT-PCR%20(WGE%20treated%20pGWB2%20SiJAZ1-9%20SiJAZ1s)%20August%208%202023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enovo\Desktop\JAZ%20repeat%20HRs\qJAZ1-9%20primers%20Bio-Rad%202-step%20qRT-PCR%20(WGE%20treated%20pGWB2%20SiJAZ1-9%20SiJAZ1s)%20August%208%20202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AF3-49F7-B062-0DA74EF7CDCF}"/>
              </c:ext>
            </c:extLst>
          </c:dPt>
          <c:dPt>
            <c:idx val="1"/>
            <c:invertIfNegative val="0"/>
            <c:bubble3D val="0"/>
            <c:spPr>
              <a:solidFill>
                <a:srgbClr val="7030A0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AF3-49F7-B062-0DA74EF7CDCF}"/>
              </c:ext>
            </c:extLst>
          </c:dPt>
          <c:errBars>
            <c:errBarType val="both"/>
            <c:errValType val="cust"/>
            <c:noEndCap val="0"/>
            <c:plus>
              <c:numRef>
                <c:f>'[Analysis for pANDA and OEJAZ Aug 1 2023.xlsx]OE-WGE'!$B$25:$C$25</c:f>
                <c:numCache>
                  <c:formatCode>General</c:formatCode>
                  <c:ptCount val="2"/>
                  <c:pt idx="0">
                    <c:v>0.65331363243820206</c:v>
                  </c:pt>
                  <c:pt idx="1">
                    <c:v>0.51782792992382565</c:v>
                  </c:pt>
                </c:numCache>
              </c:numRef>
            </c:plus>
            <c:minus>
              <c:numRef>
                <c:f>'[Analysis for pANDA and OEJAZ Aug 1 2023.xlsx]OE-WGE'!$B$25:$C$25</c:f>
                <c:numCache>
                  <c:formatCode>General</c:formatCode>
                  <c:ptCount val="2"/>
                  <c:pt idx="0">
                    <c:v>0.65331363243820206</c:v>
                  </c:pt>
                  <c:pt idx="1">
                    <c:v>0.5178279299238256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Analysis for pANDA and OEJAZ Aug 1 2023.xlsx]OE-WGE'!$D$28:$D$29</c:f>
              <c:strCache>
                <c:ptCount val="2"/>
                <c:pt idx="0">
                  <c:v>p35S::vector</c:v>
                </c:pt>
                <c:pt idx="1">
                  <c:v>p35S::GmJAZ1-9</c:v>
                </c:pt>
              </c:strCache>
            </c:strRef>
          </c:cat>
          <c:val>
            <c:numRef>
              <c:f>'[Analysis for pANDA and OEJAZ Aug 1 2023.xlsx]OE-WGE'!$E$28:$E$29</c:f>
              <c:numCache>
                <c:formatCode>General</c:formatCode>
                <c:ptCount val="2"/>
                <c:pt idx="0">
                  <c:v>10.873434</c:v>
                </c:pt>
                <c:pt idx="1">
                  <c:v>6.322976000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AF3-49F7-B062-0DA74EF7CD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358096368"/>
        <c:axId val="358097200"/>
      </c:barChart>
      <c:catAx>
        <c:axId val="3580963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8097200"/>
        <c:crosses val="autoZero"/>
        <c:auto val="1"/>
        <c:lblAlgn val="ctr"/>
        <c:lblOffset val="100"/>
        <c:noMultiLvlLbl val="0"/>
      </c:catAx>
      <c:valAx>
        <c:axId val="35809720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000" b="0" i="0" baseline="0" dirty="0" err="1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Glyceollins</a:t>
                </a:r>
                <a:r>
                  <a:rPr lang="en-US" altLang="zh-CN" sz="1000" b="0" i="0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(µg gt-1 FW)</a:t>
                </a:r>
                <a:endParaRPr lang="zh-CN" altLang="zh-CN" sz="1000" dirty="0"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80963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699-4ED2-A303-9B71EBBEFBCB}"/>
              </c:ext>
            </c:extLst>
          </c:dPt>
          <c:errBars>
            <c:errBarType val="both"/>
            <c:errValType val="cust"/>
            <c:noEndCap val="0"/>
            <c:plus>
              <c:numRef>
                <c:f>'[Analysis for pANDA and OEJAZ Aug 1 2023.xlsx]WGE'!$D$25:$E$25</c:f>
                <c:numCache>
                  <c:formatCode>General</c:formatCode>
                  <c:ptCount val="2"/>
                  <c:pt idx="0">
                    <c:v>3.1436488341952225</c:v>
                  </c:pt>
                  <c:pt idx="1">
                    <c:v>8.2034508375660664</c:v>
                  </c:pt>
                </c:numCache>
              </c:numRef>
            </c:plus>
            <c:minus>
              <c:numRef>
                <c:f>'[Analysis for pANDA and OEJAZ Aug 1 2023.xlsx]WGE'!$D$25:$E$25</c:f>
                <c:numCache>
                  <c:formatCode>General</c:formatCode>
                  <c:ptCount val="2"/>
                  <c:pt idx="0">
                    <c:v>3.1436488341952225</c:v>
                  </c:pt>
                  <c:pt idx="1">
                    <c:v>8.203450837566066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Analysis for pANDA and OEJAZ Aug 1 2023.xlsx]WGE'!$D$28:$D$29</c:f>
              <c:strCache>
                <c:ptCount val="2"/>
                <c:pt idx="0">
                  <c:v>RNAi-vector</c:v>
                </c:pt>
                <c:pt idx="1">
                  <c:v>RNAi-GmJAZ1</c:v>
                </c:pt>
              </c:strCache>
            </c:strRef>
          </c:cat>
          <c:val>
            <c:numRef>
              <c:f>'[Analysis for pANDA and OEJAZ Aug 1 2023.xlsx]WGE'!$E$28:$E$29</c:f>
              <c:numCache>
                <c:formatCode>General</c:formatCode>
                <c:ptCount val="2"/>
                <c:pt idx="0">
                  <c:v>36.916242000000004</c:v>
                </c:pt>
                <c:pt idx="1">
                  <c:v>50.275654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699-4ED2-A303-9B71EBBEFB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358096368"/>
        <c:axId val="358097200"/>
      </c:barChart>
      <c:catAx>
        <c:axId val="3580963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8097200"/>
        <c:crosses val="autoZero"/>
        <c:auto val="1"/>
        <c:lblAlgn val="ctr"/>
        <c:lblOffset val="100"/>
        <c:noMultiLvlLbl val="0"/>
      </c:catAx>
      <c:valAx>
        <c:axId val="35809720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000" b="0" i="0" baseline="0" dirty="0" err="1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Glyceollins</a:t>
                </a:r>
                <a:r>
                  <a:rPr lang="en-US" altLang="zh-CN" sz="1000" b="0" i="0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(µg gt-1 FW)</a:t>
                </a:r>
                <a:endParaRPr lang="zh-CN" altLang="zh-CN" sz="1000" dirty="0"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80963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 i="1"/>
            </a:pPr>
            <a:r>
              <a:rPr lang="en-US" altLang="zh-CN" sz="1000" i="1"/>
              <a:t>GmJAZ1-9</a:t>
            </a:r>
            <a:endParaRPr lang="en-US" sz="1000" i="1"/>
          </a:p>
        </c:rich>
      </c:tx>
      <c:layout>
        <c:manualLayout>
          <c:xMode val="edge"/>
          <c:yMode val="edge"/>
          <c:x val="0.413755888764263"/>
          <c:y val="2.9166604467542965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7.9196850393700793E-2"/>
          <c:y val="2.8252405949256341E-2"/>
          <c:w val="0.87635870516185477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B050"/>
            </a:solidFill>
            <a:ln w="12700"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 w="127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49DD-4130-9BCE-F5301C4DB39A}"/>
              </c:ext>
            </c:extLst>
          </c:dPt>
          <c:errBars>
            <c:errBarType val="both"/>
            <c:errValType val="cust"/>
            <c:noEndCap val="0"/>
            <c:plus>
              <c:numRef>
                <c:f>'[qJAZ1-9 primers Bio-Rad 2-step qRT-PCR (WGE treated pGWB2 SiJAZ1-9 SiJAZ1s) August 8 2023.xlsx]SiJAZ1-9 WGE 5D'!$J$45:$J$46</c:f>
                <c:numCache>
                  <c:formatCode>General</c:formatCode>
                  <c:ptCount val="2"/>
                  <c:pt idx="0">
                    <c:v>1.6121663014270335E-3</c:v>
                  </c:pt>
                  <c:pt idx="1">
                    <c:v>1.0113345409972644E-3</c:v>
                  </c:pt>
                </c:numCache>
              </c:numRef>
            </c:plus>
            <c:minus>
              <c:numRef>
                <c:f>'[qJAZ1-9 primers Bio-Rad 2-step qRT-PCR (WGE treated pGWB2 SiJAZ1-9 SiJAZ1s) August 8 2023.xlsx]SiJAZ1-9 WGE 5D'!$J$45:$J$46</c:f>
                <c:numCache>
                  <c:formatCode>General</c:formatCode>
                  <c:ptCount val="2"/>
                  <c:pt idx="0">
                    <c:v>1.6121663014270335E-3</c:v>
                  </c:pt>
                  <c:pt idx="1">
                    <c:v>1.0113345409972644E-3</c:v>
                  </c:pt>
                </c:numCache>
              </c:numRef>
            </c:minus>
            <c:spPr>
              <a:ln w="12700">
                <a:solidFill>
                  <a:schemeClr val="tx1">
                    <a:alpha val="96000"/>
                  </a:schemeClr>
                </a:solidFill>
              </a:ln>
            </c:spPr>
          </c:errBars>
          <c:cat>
            <c:strRef>
              <c:f>'[qJAZ1-9 primers Bio-Rad 2-step qRT-PCR (WGE treated pGWB2 SiJAZ1-9 SiJAZ1s) August 8 2023.xlsx]SiJAZ1-9 WGE 5D'!$H$45:$H$46</c:f>
              <c:strCache>
                <c:ptCount val="2"/>
                <c:pt idx="0">
                  <c:v>RNAi-vector</c:v>
                </c:pt>
                <c:pt idx="1">
                  <c:v>RNAi-GmJAZ1</c:v>
                </c:pt>
              </c:strCache>
            </c:strRef>
          </c:cat>
          <c:val>
            <c:numRef>
              <c:f>'[qJAZ1-9 primers Bio-Rad 2-step qRT-PCR (WGE treated pGWB2 SiJAZ1-9 SiJAZ1s) August 8 2023.xlsx]SiJAZ1-9 WGE 5D'!$I$45:$I$46</c:f>
              <c:numCache>
                <c:formatCode>General</c:formatCode>
                <c:ptCount val="2"/>
                <c:pt idx="0">
                  <c:v>1.5429759099215143E-2</c:v>
                </c:pt>
                <c:pt idx="1">
                  <c:v>8.354161801420352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9DD-4130-9BCE-F5301C4DB3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88522752"/>
        <c:axId val="88524288"/>
      </c:barChart>
      <c:catAx>
        <c:axId val="8852275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crossAx val="88524288"/>
        <c:crosses val="autoZero"/>
        <c:auto val="1"/>
        <c:lblAlgn val="ctr"/>
        <c:lblOffset val="100"/>
        <c:noMultiLvlLbl val="0"/>
      </c:catAx>
      <c:valAx>
        <c:axId val="8852428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crossAx val="88522752"/>
        <c:crosses val="autoZero"/>
        <c:crossBetween val="between"/>
        <c:majorUnit val="4.000000000000001E-3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 i="1"/>
            </a:pPr>
            <a:r>
              <a:rPr lang="en-US" altLang="zh-CN" sz="1000" i="1"/>
              <a:t>GmJAZ1-9</a:t>
            </a:r>
            <a:endParaRPr lang="en-US" sz="1000" i="1"/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7.9196850393700793E-2"/>
          <c:y val="2.8252405949256341E-2"/>
          <c:w val="0.87635870516185477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B050"/>
            </a:solidFill>
            <a:ln w="12700"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rgbClr val="7030A0"/>
              </a:solidFill>
              <a:ln w="127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CC56-42F0-9EE2-AA6D384BE4D2}"/>
              </c:ext>
            </c:extLst>
          </c:dPt>
          <c:errBars>
            <c:errBarType val="both"/>
            <c:errValType val="cust"/>
            <c:noEndCap val="0"/>
            <c:plus>
              <c:numRef>
                <c:f>'[qJAZ1-9 primers Bio-Rad 2-step qRT-PCR (WGE treated pGWB2 SiJAZ1-9 SiJAZ1s) August 8 2023.xlsx]OEJAZ1-9 WGE 5H'!$J$45:$J$46</c:f>
                <c:numCache>
                  <c:formatCode>General</c:formatCode>
                  <c:ptCount val="2"/>
                  <c:pt idx="0">
                    <c:v>1.0768279821649501E-3</c:v>
                  </c:pt>
                  <c:pt idx="1">
                    <c:v>8.7926470920404308E-4</c:v>
                  </c:pt>
                </c:numCache>
              </c:numRef>
            </c:plus>
            <c:minus>
              <c:numRef>
                <c:f>'[qJAZ1-9 primers Bio-Rad 2-step qRT-PCR (WGE treated pGWB2 SiJAZ1-9 SiJAZ1s) August 8 2023.xlsx]OEJAZ1-9 WGE 5H'!$J$45:$J$46</c:f>
                <c:numCache>
                  <c:formatCode>General</c:formatCode>
                  <c:ptCount val="2"/>
                  <c:pt idx="0">
                    <c:v>1.0768279821649501E-3</c:v>
                  </c:pt>
                  <c:pt idx="1">
                    <c:v>8.7926470920404308E-4</c:v>
                  </c:pt>
                </c:numCache>
              </c:numRef>
            </c:minus>
            <c:spPr>
              <a:ln w="12700">
                <a:solidFill>
                  <a:schemeClr val="tx1">
                    <a:alpha val="96000"/>
                  </a:schemeClr>
                </a:solidFill>
              </a:ln>
            </c:spPr>
          </c:errBars>
          <c:cat>
            <c:strRef>
              <c:f>'[qJAZ1-9 primers Bio-Rad 2-step qRT-PCR (WGE treated pGWB2 SiJAZ1-9 SiJAZ1s) August 8 2023.xlsx]OEJAZ1-9 WGE 5H'!$H$45:$H$46</c:f>
              <c:strCache>
                <c:ptCount val="2"/>
                <c:pt idx="0">
                  <c:v>p35S::vector</c:v>
                </c:pt>
                <c:pt idx="1">
                  <c:v>p35S::GmJAZ1-9</c:v>
                </c:pt>
              </c:strCache>
            </c:strRef>
          </c:cat>
          <c:val>
            <c:numRef>
              <c:f>'[qJAZ1-9 primers Bio-Rad 2-step qRT-PCR (WGE treated pGWB2 SiJAZ1-9 SiJAZ1s) August 8 2023.xlsx]OEJAZ1-9 WGE 5H'!$I$45:$I$46</c:f>
              <c:numCache>
                <c:formatCode>General</c:formatCode>
                <c:ptCount val="2"/>
                <c:pt idx="0">
                  <c:v>7.781787623258503E-3</c:v>
                </c:pt>
                <c:pt idx="1">
                  <c:v>1.027367940740434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C56-42F0-9EE2-AA6D384BE4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88522752"/>
        <c:axId val="88524288"/>
      </c:barChart>
      <c:catAx>
        <c:axId val="8852275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crossAx val="88524288"/>
        <c:crosses val="autoZero"/>
        <c:auto val="1"/>
        <c:lblAlgn val="ctr"/>
        <c:lblOffset val="100"/>
        <c:noMultiLvlLbl val="0"/>
      </c:catAx>
      <c:valAx>
        <c:axId val="8852428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crossAx val="8852275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6B57D-5FA8-4B0D-ABF9-31C9FF90A2E9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58541-03EE-4B64-B9D7-56248ED1CB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01855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6B57D-5FA8-4B0D-ABF9-31C9FF90A2E9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58541-03EE-4B64-B9D7-56248ED1CB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1486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6B57D-5FA8-4B0D-ABF9-31C9FF90A2E9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58541-03EE-4B64-B9D7-56248ED1CB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60441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6B57D-5FA8-4B0D-ABF9-31C9FF90A2E9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58541-03EE-4B64-B9D7-56248ED1CB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5942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6B57D-5FA8-4B0D-ABF9-31C9FF90A2E9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58541-03EE-4B64-B9D7-56248ED1CB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34042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6B57D-5FA8-4B0D-ABF9-31C9FF90A2E9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58541-03EE-4B64-B9D7-56248ED1CB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27508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6B57D-5FA8-4B0D-ABF9-31C9FF90A2E9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58541-03EE-4B64-B9D7-56248ED1CB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39163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6B57D-5FA8-4B0D-ABF9-31C9FF90A2E9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58541-03EE-4B64-B9D7-56248ED1CB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69601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6B57D-5FA8-4B0D-ABF9-31C9FF90A2E9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58541-03EE-4B64-B9D7-56248ED1CB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78473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6B57D-5FA8-4B0D-ABF9-31C9FF90A2E9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58541-03EE-4B64-B9D7-56248ED1CB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29146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6B57D-5FA8-4B0D-ABF9-31C9FF90A2E9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58541-03EE-4B64-B9D7-56248ED1CB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59613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56B57D-5FA8-4B0D-ABF9-31C9FF90A2E9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F58541-03EE-4B64-B9D7-56248ED1CB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0186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图表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50052111"/>
              </p:ext>
            </p:extLst>
          </p:nvPr>
        </p:nvGraphicFramePr>
        <p:xfrm>
          <a:off x="5834181" y="3224742"/>
          <a:ext cx="2718485" cy="26731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图表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88032436"/>
              </p:ext>
            </p:extLst>
          </p:nvPr>
        </p:nvGraphicFramePr>
        <p:xfrm>
          <a:off x="3107382" y="3209585"/>
          <a:ext cx="2666299" cy="26869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Chart 1">
            <a:extLst>
              <a:ext uri="{FF2B5EF4-FFF2-40B4-BE49-F238E27FC236}">
                <a16:creationId xmlns:a16="http://schemas.microsoft.com/office/drawing/2014/main" id="{40C2BC48-B473-467B-A980-0B2AEB0894A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00396501"/>
              </p:ext>
            </p:extLst>
          </p:nvPr>
        </p:nvGraphicFramePr>
        <p:xfrm>
          <a:off x="3446592" y="576648"/>
          <a:ext cx="2427517" cy="26125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" name="Chart 1">
            <a:extLst>
              <a:ext uri="{FF2B5EF4-FFF2-40B4-BE49-F238E27FC236}">
                <a16:creationId xmlns:a16="http://schemas.microsoft.com/office/drawing/2014/main" id="{40C2BC48-B473-467B-A980-0B2AEB0894A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25677836"/>
              </p:ext>
            </p:extLst>
          </p:nvPr>
        </p:nvGraphicFramePr>
        <p:xfrm>
          <a:off x="5934609" y="587630"/>
          <a:ext cx="2618057" cy="26125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1" name="文本框 10"/>
          <p:cNvSpPr txBox="1"/>
          <p:nvPr/>
        </p:nvSpPr>
        <p:spPr>
          <a:xfrm>
            <a:off x="2768172" y="156519"/>
            <a:ext cx="6784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5923005" y="156519"/>
            <a:ext cx="6784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742864" y="6023990"/>
            <a:ext cx="1064182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S5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epeat the hairy root experiments for Figures 4A,4C, 4E, 4F. (A)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GmJAZ1-9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Gene expression. (B) amounts of total glyceollin metabolites in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RNAi-GmJAZ1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W82 hairy roots elicited for 24 h with WGE. (C)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GmJAZ1-9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Gene expression. (D) amounts of total glyceollin metabolites in W82 hairy roots overexpressing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GmJAZ1-9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elicited for 24 h with WGE. </a:t>
            </a:r>
            <a:r>
              <a:rPr lang="en-US" altLang="zh-CN" sz="1000" baseline="300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</a:t>
            </a:r>
            <a:r>
              <a:rPr lang="en-US" altLang="zh-CN" sz="10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ignificantly greater or less than control, paired students t-test (P &lt; 0.05). Error bars represent SE (n = 5). </a:t>
            </a:r>
            <a:r>
              <a:rPr lang="en-US" altLang="zh-CN" sz="10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For a list of statistical values, see Supplementary Table S9, S11, S13, S14, respectively.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5256472" y="1550010"/>
            <a:ext cx="4351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7802691" y="4185315"/>
            <a:ext cx="4351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5030660" y="3516390"/>
            <a:ext cx="4351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/>
          <p:cNvSpPr/>
          <p:nvPr/>
        </p:nvSpPr>
        <p:spPr>
          <a:xfrm rot="16200000">
            <a:off x="2085578" y="1550011"/>
            <a:ext cx="241765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800" b="0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CA" altLang="zh-CN" sz="1000" dirty="0"/>
              <a:t>Log2 Fold Change (Gene/</a:t>
            </a:r>
            <a:r>
              <a:rPr lang="en-CA" altLang="zh-CN" sz="1000" i="1" dirty="0"/>
              <a:t>UBIQUITIN3</a:t>
            </a:r>
            <a:r>
              <a:rPr lang="en-CA" altLang="zh-CN" sz="1000" dirty="0"/>
              <a:t>)</a:t>
            </a:r>
            <a:endParaRPr lang="zh-CN" altLang="zh-CN" sz="1000" dirty="0"/>
          </a:p>
        </p:txBody>
      </p:sp>
      <p:sp>
        <p:nvSpPr>
          <p:cNvPr id="18" name="文本框 14">
            <a:extLst>
              <a:ext uri="{FF2B5EF4-FFF2-40B4-BE49-F238E27FC236}">
                <a16:creationId xmlns:a16="http://schemas.microsoft.com/office/drawing/2014/main" id="{629CC01F-354E-4E2A-B671-418794A12571}"/>
              </a:ext>
            </a:extLst>
          </p:cNvPr>
          <p:cNvSpPr txBox="1"/>
          <p:nvPr/>
        </p:nvSpPr>
        <p:spPr>
          <a:xfrm>
            <a:off x="7871985" y="573826"/>
            <a:ext cx="4351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2">
            <a:extLst>
              <a:ext uri="{FF2B5EF4-FFF2-40B4-BE49-F238E27FC236}">
                <a16:creationId xmlns:a16="http://schemas.microsoft.com/office/drawing/2014/main" id="{82FD0CA1-31E6-46C3-91F5-05EA611210BC}"/>
              </a:ext>
            </a:extLst>
          </p:cNvPr>
          <p:cNvSpPr txBox="1"/>
          <p:nvPr/>
        </p:nvSpPr>
        <p:spPr>
          <a:xfrm>
            <a:off x="2802813" y="3036074"/>
            <a:ext cx="6784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12">
            <a:extLst>
              <a:ext uri="{FF2B5EF4-FFF2-40B4-BE49-F238E27FC236}">
                <a16:creationId xmlns:a16="http://schemas.microsoft.com/office/drawing/2014/main" id="{014F1BC8-3579-4A22-8623-8319E152B6AC}"/>
              </a:ext>
            </a:extLst>
          </p:cNvPr>
          <p:cNvSpPr txBox="1"/>
          <p:nvPr/>
        </p:nvSpPr>
        <p:spPr>
          <a:xfrm>
            <a:off x="5914984" y="3020033"/>
            <a:ext cx="6784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76357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5</TotalTime>
  <Words>159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宋体</vt:lpstr>
      <vt:lpstr>宋体</vt:lpstr>
      <vt:lpstr>Arial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林 洁</dc:creator>
  <cp:lastModifiedBy>Nik Kovinich</cp:lastModifiedBy>
  <cp:revision>20</cp:revision>
  <dcterms:created xsi:type="dcterms:W3CDTF">2023-08-24T00:26:58Z</dcterms:created>
  <dcterms:modified xsi:type="dcterms:W3CDTF">2024-09-20T16:41:45Z</dcterms:modified>
</cp:coreProperties>
</file>